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B6B956-3087-42CF-9326-1E549F0DE5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F69733-2BFF-4900-BED8-85665989D8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60158-1F76-41BE-AC2E-47CC845EE9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7318B-01D9-4A14-9FD3-3B80D346BF8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A9761D-C2AF-4CBB-BF28-D89F92CE5D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0D84C0-6ED6-4FEB-B63C-598074FFC0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BDCAF-F285-42F2-BB83-A10BB425DC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5E69D6-10A3-4916-B41B-FEC9703CA1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91DBBA-54EB-4B6E-8A76-0FB122F9DC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A5D87F-1F79-4725-8691-F1D3F07F83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4749DC-AB94-4B3C-9339-26C842AAC3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A80A0-E8A2-4B95-8008-E3BE583482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694006-40DD-4542-AD50-1619A4329B4F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그룹 22"/>
          <p:cNvGrpSpPr/>
          <p:nvPr/>
        </p:nvGrpSpPr>
        <p:grpSpPr>
          <a:xfrm>
            <a:off x="228600" y="1428840"/>
            <a:ext cx="8772480" cy="3999960"/>
            <a:chOff x="228600" y="1428840"/>
            <a:chExt cx="8772480" cy="3999960"/>
          </a:xfrm>
        </p:grpSpPr>
        <p:pic>
          <p:nvPicPr>
            <p:cNvPr id="42" name="Picture 2" descr="C:\Documents and Settings\a\My Documents\내 스캔\2007-11 (11월)\스캔0002.jpg"/>
            <p:cNvPicPr/>
            <p:nvPr/>
          </p:nvPicPr>
          <p:blipFill>
            <a:blip r:embed="rId1"/>
            <a:srcRect l="71185" t="71648" r="7174" b="13415"/>
            <a:stretch/>
          </p:blipFill>
          <p:spPr>
            <a:xfrm>
              <a:off x="5263200" y="1903320"/>
              <a:ext cx="3737880" cy="3335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2"/>
            <p:cNvSpPr/>
            <p:nvPr/>
          </p:nvSpPr>
          <p:spPr>
            <a:xfrm>
              <a:off x="5888160" y="3300840"/>
              <a:ext cx="48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81%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4" name="TextBox 3"/>
            <p:cNvSpPr/>
            <p:nvPr/>
          </p:nvSpPr>
          <p:spPr>
            <a:xfrm>
              <a:off x="8386920" y="3300840"/>
              <a:ext cx="4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4%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5" name="TextBox 4"/>
            <p:cNvSpPr/>
            <p:nvPr/>
          </p:nvSpPr>
          <p:spPr>
            <a:xfrm>
              <a:off x="8386920" y="1903320"/>
              <a:ext cx="4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8%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6" name="TextBox 5"/>
            <p:cNvSpPr/>
            <p:nvPr/>
          </p:nvSpPr>
          <p:spPr>
            <a:xfrm>
              <a:off x="5888160" y="1903320"/>
              <a:ext cx="4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7%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47" name="Picture 4" descr="C:\Documents and Settings\a\My Documents\내 스캔\2007-11 (11월)\스캔0006.jpg"/>
            <p:cNvPicPr/>
            <p:nvPr/>
          </p:nvPicPr>
          <p:blipFill>
            <a:blip r:embed="rId2"/>
            <a:srcRect l="28269" t="11391" r="50715" b="43425"/>
            <a:stretch/>
          </p:blipFill>
          <p:spPr>
            <a:xfrm>
              <a:off x="487080" y="1903320"/>
              <a:ext cx="3737880" cy="3335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TextBox 7"/>
            <p:cNvSpPr/>
            <p:nvPr/>
          </p:nvSpPr>
          <p:spPr>
            <a:xfrm>
              <a:off x="1008000" y="3225240"/>
              <a:ext cx="48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90%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" name="TextBox 8"/>
            <p:cNvSpPr/>
            <p:nvPr/>
          </p:nvSpPr>
          <p:spPr>
            <a:xfrm>
              <a:off x="3299040" y="3225240"/>
              <a:ext cx="4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2%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" name="TextBox 9"/>
            <p:cNvSpPr/>
            <p:nvPr/>
          </p:nvSpPr>
          <p:spPr>
            <a:xfrm>
              <a:off x="3299040" y="2013480"/>
              <a:ext cx="4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3%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1" name="TextBox 10"/>
            <p:cNvSpPr/>
            <p:nvPr/>
          </p:nvSpPr>
          <p:spPr>
            <a:xfrm>
              <a:off x="1008000" y="2013480"/>
              <a:ext cx="4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5%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" name="Line 26"/>
            <p:cNvSpPr/>
            <p:nvPr/>
          </p:nvSpPr>
          <p:spPr>
            <a:xfrm flipV="1">
              <a:off x="1213560" y="5344200"/>
              <a:ext cx="668880" cy="11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3" name="Text Box 27"/>
            <p:cNvSpPr/>
            <p:nvPr/>
          </p:nvSpPr>
          <p:spPr>
            <a:xfrm>
              <a:off x="1816920" y="5143680"/>
              <a:ext cx="1181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Anexin V-FITC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4" name="Line 26"/>
            <p:cNvSpPr/>
            <p:nvPr/>
          </p:nvSpPr>
          <p:spPr>
            <a:xfrm flipV="1">
              <a:off x="6278400" y="5344200"/>
              <a:ext cx="668880" cy="11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" name="Text Box 27"/>
            <p:cNvSpPr/>
            <p:nvPr/>
          </p:nvSpPr>
          <p:spPr>
            <a:xfrm>
              <a:off x="6881760" y="5152320"/>
              <a:ext cx="1181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Anexin V-FITC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6" name="Line 22"/>
            <p:cNvSpPr/>
            <p:nvPr/>
          </p:nvSpPr>
          <p:spPr>
            <a:xfrm flipV="1">
              <a:off x="412920" y="3571560"/>
              <a:ext cx="0" cy="92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7" name="Rectangle 23"/>
            <p:cNvSpPr/>
            <p:nvPr/>
          </p:nvSpPr>
          <p:spPr>
            <a:xfrm rot="16200000">
              <a:off x="-339840" y="2692800"/>
              <a:ext cx="141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Propidium Iodide  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8" name="Line 22"/>
            <p:cNvSpPr/>
            <p:nvPr/>
          </p:nvSpPr>
          <p:spPr>
            <a:xfrm flipV="1">
              <a:off x="5189400" y="3785760"/>
              <a:ext cx="0" cy="92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9" name="Rectangle 23"/>
            <p:cNvSpPr/>
            <p:nvPr/>
          </p:nvSpPr>
          <p:spPr>
            <a:xfrm rot="16200000">
              <a:off x="4435920" y="2927880"/>
              <a:ext cx="141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Propidium Iodide  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0" name="Text Box 43"/>
            <p:cNvSpPr/>
            <p:nvPr/>
          </p:nvSpPr>
          <p:spPr>
            <a:xfrm>
              <a:off x="1529640" y="1428840"/>
              <a:ext cx="1235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Anti mouse IgG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1" name="Text Box 43"/>
            <p:cNvSpPr/>
            <p:nvPr/>
          </p:nvSpPr>
          <p:spPr>
            <a:xfrm>
              <a:off x="6639120" y="1538640"/>
              <a:ext cx="877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Anti CD24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62" name="TextBox 102"/>
          <p:cNvSpPr/>
          <p:nvPr/>
        </p:nvSpPr>
        <p:spPr>
          <a:xfrm>
            <a:off x="393120" y="214200"/>
            <a:ext cx="1747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33"/>
                </a:solidFill>
                <a:latin typeface="Times New Roman"/>
                <a:ea typeface="돋움"/>
              </a:rPr>
              <a:t>Additional File 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바탕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23T04:19:02Z</dcterms:created>
  <dc:creator>a</dc:creator>
  <dc:description/>
  <dc:language>en-US</dc:language>
  <cp:lastModifiedBy>a</cp:lastModifiedBy>
  <dcterms:modified xsi:type="dcterms:W3CDTF">2008-04-23T06:57:20Z</dcterms:modified>
  <cp:revision>11</cp:revision>
  <dc:subject/>
  <dc:title>슬라이드 1</dc:title>
</cp:coreProperties>
</file>